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8" r:id="rId4"/>
    <p:sldId id="269" r:id="rId5"/>
    <p:sldId id="270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748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le Hiam" userId="2f95a3e9-2108-49b9-8f1d-5e049cddd44e" providerId="ADAL" clId="{AB6DBDA0-17BE-4E2B-8A05-2B7DA327379D}"/>
    <pc:docChg chg="undo custSel addSld modSld">
      <pc:chgData name="Danielle Hiam" userId="2f95a3e9-2108-49b9-8f1d-5e049cddd44e" providerId="ADAL" clId="{AB6DBDA0-17BE-4E2B-8A05-2B7DA327379D}" dt="2023-04-19T04:10:06.226" v="295" actId="20577"/>
      <pc:docMkLst>
        <pc:docMk/>
      </pc:docMkLst>
      <pc:sldChg chg="addSp modSp mod">
        <pc:chgData name="Danielle Hiam" userId="2f95a3e9-2108-49b9-8f1d-5e049cddd44e" providerId="ADAL" clId="{AB6DBDA0-17BE-4E2B-8A05-2B7DA327379D}" dt="2023-04-18T05:58:00.908" v="265" actId="1076"/>
        <pc:sldMkLst>
          <pc:docMk/>
          <pc:sldMk cId="1571900791" sldId="257"/>
        </pc:sldMkLst>
        <pc:spChg chg="add mod">
          <ac:chgData name="Danielle Hiam" userId="2f95a3e9-2108-49b9-8f1d-5e049cddd44e" providerId="ADAL" clId="{AB6DBDA0-17BE-4E2B-8A05-2B7DA327379D}" dt="2023-04-18T05:58:00.908" v="265" actId="1076"/>
          <ac:spMkLst>
            <pc:docMk/>
            <pc:sldMk cId="1571900791" sldId="257"/>
            <ac:spMk id="3" creationId="{82B2B297-EAB6-047F-E65A-5576ED04A227}"/>
          </ac:spMkLst>
        </pc:spChg>
        <pc:picChg chg="add mod">
          <ac:chgData name="Danielle Hiam" userId="2f95a3e9-2108-49b9-8f1d-5e049cddd44e" providerId="ADAL" clId="{AB6DBDA0-17BE-4E2B-8A05-2B7DA327379D}" dt="2023-04-18T05:54:41.873" v="6" actId="1076"/>
          <ac:picMkLst>
            <pc:docMk/>
            <pc:sldMk cId="1571900791" sldId="257"/>
            <ac:picMk id="5" creationId="{C3C99EB4-6A2F-EB31-7594-0DEC1C1DA1EB}"/>
          </ac:picMkLst>
        </pc:picChg>
      </pc:sldChg>
      <pc:sldChg chg="addSp modSp new mod">
        <pc:chgData name="Danielle Hiam" userId="2f95a3e9-2108-49b9-8f1d-5e049cddd44e" providerId="ADAL" clId="{AB6DBDA0-17BE-4E2B-8A05-2B7DA327379D}" dt="2023-04-19T04:10:06.226" v="295" actId="20577"/>
        <pc:sldMkLst>
          <pc:docMk/>
          <pc:sldMk cId="3331233458" sldId="269"/>
        </pc:sldMkLst>
        <pc:spChg chg="add mod">
          <ac:chgData name="Danielle Hiam" userId="2f95a3e9-2108-49b9-8f1d-5e049cddd44e" providerId="ADAL" clId="{AB6DBDA0-17BE-4E2B-8A05-2B7DA327379D}" dt="2023-04-19T04:10:06.226" v="295" actId="20577"/>
          <ac:spMkLst>
            <pc:docMk/>
            <pc:sldMk cId="3331233458" sldId="269"/>
            <ac:spMk id="5" creationId="{57067E7D-6D8E-8D98-D4B6-101038A860AE}"/>
          </ac:spMkLst>
        </pc:spChg>
        <pc:picChg chg="add mod">
          <ac:chgData name="Danielle Hiam" userId="2f95a3e9-2108-49b9-8f1d-5e049cddd44e" providerId="ADAL" clId="{AB6DBDA0-17BE-4E2B-8A05-2B7DA327379D}" dt="2023-04-19T04:09:28.505" v="274" actId="1076"/>
          <ac:picMkLst>
            <pc:docMk/>
            <pc:sldMk cId="3331233458" sldId="269"/>
            <ac:picMk id="3" creationId="{398F53E5-5724-5D66-E74A-373E696A2A22}"/>
          </ac:picMkLst>
        </pc:picChg>
      </pc:sldChg>
    </pc:docChg>
  </pc:docChgLst>
  <pc:docChgLst>
    <pc:chgData name="Danielle Hiam" userId="2f95a3e9-2108-49b9-8f1d-5e049cddd44e" providerId="ADAL" clId="{D692491E-C771-4E53-83B4-6C2A02E8D85A}"/>
    <pc:docChg chg="undo custSel addSld modSld">
      <pc:chgData name="Danielle Hiam" userId="2f95a3e9-2108-49b9-8f1d-5e049cddd44e" providerId="ADAL" clId="{D692491E-C771-4E53-83B4-6C2A02E8D85A}" dt="2023-08-26T22:26:32.457" v="795" actId="164"/>
      <pc:docMkLst>
        <pc:docMk/>
      </pc:docMkLst>
      <pc:sldChg chg="addSp delSp modSp mod">
        <pc:chgData name="Danielle Hiam" userId="2f95a3e9-2108-49b9-8f1d-5e049cddd44e" providerId="ADAL" clId="{D692491E-C771-4E53-83B4-6C2A02E8D85A}" dt="2023-08-13T22:54:22.020" v="389" actId="27614"/>
        <pc:sldMkLst>
          <pc:docMk/>
          <pc:sldMk cId="1571900791" sldId="257"/>
        </pc:sldMkLst>
        <pc:spChg chg="mod">
          <ac:chgData name="Danielle Hiam" userId="2f95a3e9-2108-49b9-8f1d-5e049cddd44e" providerId="ADAL" clId="{D692491E-C771-4E53-83B4-6C2A02E8D85A}" dt="2023-08-13T08:36:53.759" v="386" actId="20577"/>
          <ac:spMkLst>
            <pc:docMk/>
            <pc:sldMk cId="1571900791" sldId="257"/>
            <ac:spMk id="3" creationId="{82B2B297-EAB6-047F-E65A-5576ED04A227}"/>
          </ac:spMkLst>
        </pc:spChg>
        <pc:picChg chg="add del mod">
          <ac:chgData name="Danielle Hiam" userId="2f95a3e9-2108-49b9-8f1d-5e049cddd44e" providerId="ADAL" clId="{D692491E-C771-4E53-83B4-6C2A02E8D85A}" dt="2023-08-13T08:36:56.687" v="387" actId="478"/>
          <ac:picMkLst>
            <pc:docMk/>
            <pc:sldMk cId="1571900791" sldId="257"/>
            <ac:picMk id="4" creationId="{14400626-FAB2-17DC-3B77-EEA42822900B}"/>
          </ac:picMkLst>
        </pc:picChg>
        <pc:picChg chg="del">
          <ac:chgData name="Danielle Hiam" userId="2f95a3e9-2108-49b9-8f1d-5e049cddd44e" providerId="ADAL" clId="{D692491E-C771-4E53-83B4-6C2A02E8D85A}" dt="2023-08-13T08:31:45.706" v="178" actId="478"/>
          <ac:picMkLst>
            <pc:docMk/>
            <pc:sldMk cId="1571900791" sldId="257"/>
            <ac:picMk id="5" creationId="{C3C99EB4-6A2F-EB31-7594-0DEC1C1DA1EB}"/>
          </ac:picMkLst>
        </pc:picChg>
        <pc:picChg chg="add mod">
          <ac:chgData name="Danielle Hiam" userId="2f95a3e9-2108-49b9-8f1d-5e049cddd44e" providerId="ADAL" clId="{D692491E-C771-4E53-83B4-6C2A02E8D85A}" dt="2023-08-13T22:54:22.020" v="389" actId="27614"/>
          <ac:picMkLst>
            <pc:docMk/>
            <pc:sldMk cId="1571900791" sldId="257"/>
            <ac:picMk id="7" creationId="{7094FDB3-1C3B-3272-B639-A7E41BCBEEF5}"/>
          </ac:picMkLst>
        </pc:picChg>
      </pc:sldChg>
      <pc:sldChg chg="modSp mod">
        <pc:chgData name="Danielle Hiam" userId="2f95a3e9-2108-49b9-8f1d-5e049cddd44e" providerId="ADAL" clId="{D692491E-C771-4E53-83B4-6C2A02E8D85A}" dt="2023-08-16T04:27:01.302" v="390" actId="1076"/>
        <pc:sldMkLst>
          <pc:docMk/>
          <pc:sldMk cId="2692084418" sldId="268"/>
        </pc:sldMkLst>
        <pc:spChg chg="mod">
          <ac:chgData name="Danielle Hiam" userId="2f95a3e9-2108-49b9-8f1d-5e049cddd44e" providerId="ADAL" clId="{D692491E-C771-4E53-83B4-6C2A02E8D85A}" dt="2023-08-16T04:27:01.302" v="390" actId="1076"/>
          <ac:spMkLst>
            <pc:docMk/>
            <pc:sldMk cId="2692084418" sldId="268"/>
            <ac:spMk id="4" creationId="{59EDA069-83CF-A4FD-194F-203284533923}"/>
          </ac:spMkLst>
        </pc:spChg>
      </pc:sldChg>
      <pc:sldChg chg="addSp delSp modSp new mod">
        <pc:chgData name="Danielle Hiam" userId="2f95a3e9-2108-49b9-8f1d-5e049cddd44e" providerId="ADAL" clId="{D692491E-C771-4E53-83B4-6C2A02E8D85A}" dt="2023-08-26T22:26:32.457" v="795" actId="164"/>
        <pc:sldMkLst>
          <pc:docMk/>
          <pc:sldMk cId="1249892383" sldId="270"/>
        </pc:sldMkLst>
        <pc:spChg chg="add mod topLvl">
          <ac:chgData name="Danielle Hiam" userId="2f95a3e9-2108-49b9-8f1d-5e049cddd44e" providerId="ADAL" clId="{D692491E-C771-4E53-83B4-6C2A02E8D85A}" dt="2023-08-26T22:26:32.457" v="795" actId="164"/>
          <ac:spMkLst>
            <pc:docMk/>
            <pc:sldMk cId="1249892383" sldId="270"/>
            <ac:spMk id="4" creationId="{38BD5D50-7167-3DD8-3BD5-E3A820964870}"/>
          </ac:spMkLst>
        </pc:spChg>
        <pc:grpChg chg="add del mod">
          <ac:chgData name="Danielle Hiam" userId="2f95a3e9-2108-49b9-8f1d-5e049cddd44e" providerId="ADAL" clId="{D692491E-C771-4E53-83B4-6C2A02E8D85A}" dt="2023-08-26T22:21:38.124" v="680" actId="165"/>
          <ac:grpSpMkLst>
            <pc:docMk/>
            <pc:sldMk cId="1249892383" sldId="270"/>
            <ac:grpSpMk id="5" creationId="{E443B74C-EA9D-25D4-3C2F-1F4C3EAD5F22}"/>
          </ac:grpSpMkLst>
        </pc:grpChg>
        <pc:grpChg chg="add mod">
          <ac:chgData name="Danielle Hiam" userId="2f95a3e9-2108-49b9-8f1d-5e049cddd44e" providerId="ADAL" clId="{D692491E-C771-4E53-83B4-6C2A02E8D85A}" dt="2023-08-26T22:26:32.457" v="795" actId="164"/>
          <ac:grpSpMkLst>
            <pc:docMk/>
            <pc:sldMk cId="1249892383" sldId="270"/>
            <ac:grpSpMk id="12" creationId="{60793B49-8D7D-3B4B-727C-8245B4CF48B7}"/>
          </ac:grpSpMkLst>
        </pc:grpChg>
        <pc:picChg chg="add del mod topLvl">
          <ac:chgData name="Danielle Hiam" userId="2f95a3e9-2108-49b9-8f1d-5e049cddd44e" providerId="ADAL" clId="{D692491E-C771-4E53-83B4-6C2A02E8D85A}" dt="2023-08-26T22:22:32.360" v="730" actId="478"/>
          <ac:picMkLst>
            <pc:docMk/>
            <pc:sldMk cId="1249892383" sldId="270"/>
            <ac:picMk id="3" creationId="{F7BB24FC-AE25-6EEE-8C58-7EFBAD4B226B}"/>
          </ac:picMkLst>
        </pc:picChg>
        <pc:picChg chg="add del mod">
          <ac:chgData name="Danielle Hiam" userId="2f95a3e9-2108-49b9-8f1d-5e049cddd44e" providerId="ADAL" clId="{D692491E-C771-4E53-83B4-6C2A02E8D85A}" dt="2023-08-26T22:20:52.700" v="671" actId="478"/>
          <ac:picMkLst>
            <pc:docMk/>
            <pc:sldMk cId="1249892383" sldId="270"/>
            <ac:picMk id="7" creationId="{FA0F5CD5-9F88-E39B-125D-470703198341}"/>
          </ac:picMkLst>
        </pc:picChg>
        <pc:picChg chg="add mod">
          <ac:chgData name="Danielle Hiam" userId="2f95a3e9-2108-49b9-8f1d-5e049cddd44e" providerId="ADAL" clId="{D692491E-C771-4E53-83B4-6C2A02E8D85A}" dt="2023-08-26T22:26:32.457" v="795" actId="164"/>
          <ac:picMkLst>
            <pc:docMk/>
            <pc:sldMk cId="1249892383" sldId="270"/>
            <ac:picMk id="9" creationId="{F7BC49C1-EF17-A937-39B8-BB4D8FF91FC8}"/>
          </ac:picMkLst>
        </pc:picChg>
        <pc:picChg chg="add mod">
          <ac:chgData name="Danielle Hiam" userId="2f95a3e9-2108-49b9-8f1d-5e049cddd44e" providerId="ADAL" clId="{D692491E-C771-4E53-83B4-6C2A02E8D85A}" dt="2023-08-26T22:26:32.457" v="795" actId="164"/>
          <ac:picMkLst>
            <pc:docMk/>
            <pc:sldMk cId="1249892383" sldId="270"/>
            <ac:picMk id="11" creationId="{03BC018D-C614-7E32-EE40-DF38D4FB6696}"/>
          </ac:picMkLst>
        </pc:picChg>
      </pc:sldChg>
    </pc:docChg>
  </pc:docChgLst>
  <pc:docChgLst>
    <pc:chgData name="Danielle Hiam" userId="2f95a3e9-2108-49b9-8f1d-5e049cddd44e" providerId="ADAL" clId="{4E32C224-17B6-43F6-8BA1-DF842E390849}"/>
    <pc:docChg chg="custSel modSld">
      <pc:chgData name="Danielle Hiam" userId="2f95a3e9-2108-49b9-8f1d-5e049cddd44e" providerId="ADAL" clId="{4E32C224-17B6-43F6-8BA1-DF842E390849}" dt="2023-10-05T22:47:03.946" v="25" actId="20577"/>
      <pc:docMkLst>
        <pc:docMk/>
      </pc:docMkLst>
      <pc:sldChg chg="modSp mod">
        <pc:chgData name="Danielle Hiam" userId="2f95a3e9-2108-49b9-8f1d-5e049cddd44e" providerId="ADAL" clId="{4E32C224-17B6-43F6-8BA1-DF842E390849}" dt="2023-10-05T22:46:36.375" v="5" actId="6549"/>
        <pc:sldMkLst>
          <pc:docMk/>
          <pc:sldMk cId="2692084418" sldId="268"/>
        </pc:sldMkLst>
        <pc:spChg chg="mod">
          <ac:chgData name="Danielle Hiam" userId="2f95a3e9-2108-49b9-8f1d-5e049cddd44e" providerId="ADAL" clId="{4E32C224-17B6-43F6-8BA1-DF842E390849}" dt="2023-10-05T22:46:36.375" v="5" actId="6549"/>
          <ac:spMkLst>
            <pc:docMk/>
            <pc:sldMk cId="2692084418" sldId="268"/>
            <ac:spMk id="4" creationId="{59EDA069-83CF-A4FD-194F-203284533923}"/>
          </ac:spMkLst>
        </pc:spChg>
      </pc:sldChg>
      <pc:sldChg chg="modSp mod">
        <pc:chgData name="Danielle Hiam" userId="2f95a3e9-2108-49b9-8f1d-5e049cddd44e" providerId="ADAL" clId="{4E32C224-17B6-43F6-8BA1-DF842E390849}" dt="2023-10-05T22:46:50.861" v="19" actId="20577"/>
        <pc:sldMkLst>
          <pc:docMk/>
          <pc:sldMk cId="3331233458" sldId="269"/>
        </pc:sldMkLst>
        <pc:spChg chg="mod">
          <ac:chgData name="Danielle Hiam" userId="2f95a3e9-2108-49b9-8f1d-5e049cddd44e" providerId="ADAL" clId="{4E32C224-17B6-43F6-8BA1-DF842E390849}" dt="2023-10-05T22:46:50.861" v="19" actId="20577"/>
          <ac:spMkLst>
            <pc:docMk/>
            <pc:sldMk cId="3331233458" sldId="269"/>
            <ac:spMk id="5" creationId="{57067E7D-6D8E-8D98-D4B6-101038A860AE}"/>
          </ac:spMkLst>
        </pc:spChg>
      </pc:sldChg>
      <pc:sldChg chg="modSp mod">
        <pc:chgData name="Danielle Hiam" userId="2f95a3e9-2108-49b9-8f1d-5e049cddd44e" providerId="ADAL" clId="{4E32C224-17B6-43F6-8BA1-DF842E390849}" dt="2023-10-05T22:47:03.946" v="25" actId="20577"/>
        <pc:sldMkLst>
          <pc:docMk/>
          <pc:sldMk cId="1249892383" sldId="270"/>
        </pc:sldMkLst>
        <pc:spChg chg="mod">
          <ac:chgData name="Danielle Hiam" userId="2f95a3e9-2108-49b9-8f1d-5e049cddd44e" providerId="ADAL" clId="{4E32C224-17B6-43F6-8BA1-DF842E390849}" dt="2023-10-05T22:47:03.946" v="25" actId="20577"/>
          <ac:spMkLst>
            <pc:docMk/>
            <pc:sldMk cId="1249892383" sldId="270"/>
            <ac:spMk id="4" creationId="{38BD5D50-7167-3DD8-3BD5-E3A82096487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3154E6-F439-5CBB-D8D7-7A572B6FB2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0EAEA8-4E7D-695B-D039-121625CF41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3594C7-603E-6A64-61C9-77C82D1C18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B07324-2ADD-E532-FE7B-4AABD0E4D9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E6C61A-B48D-FE84-5D12-60F0D718AA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92278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65C821-7F10-1A12-93BB-706ABD8382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03EA9B-B35B-A53E-CCB0-E6601C84FE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0CC9E6-E380-F74D-8D9D-1F4FD053A9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3EA19B-1DE3-8A99-D429-4DE54CD18C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7DF875-5734-F75C-387A-0ED646B9F5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840360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B556D87-3CAD-9903-4AE9-75055DE5689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4DC028-084B-C463-1D80-2EC75C6257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9A6339-E517-FA14-A4AA-D9F2C9D28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7B84BA-9C5E-3DAD-12BF-36A8B9EC7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40D74EA-174A-EFB7-CE0A-7F2B0AFC67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75581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9F7B3F-DD3D-2939-A1A7-ABDB2D1392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A6FBA8-1813-2F63-4397-E92EA3CB6AF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8AA452-9F01-013E-EA7D-C57D78482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3E6AF0-B223-6FC3-3E8A-F5675AB251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A40ED2-27FC-87AC-8D8A-7A70CCFBF4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0129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84BC72-4172-30E0-F497-996EEE9BCE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8A08F9-4C8E-5781-21F7-9A94BD1BED7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064EEB-818C-6C32-4BA2-C423D3850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54B38B-80A5-8FF6-5A70-67DDFA5C7D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905803-A3B6-7E14-4F76-39C7552B52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265619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EB8FBC-FAB5-C23C-96B0-74FF31F631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B5848D-0A94-AC0A-2BAC-1652F9D692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B5F212-0084-60D2-FB5D-178C82D0B3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8679457-BB54-8579-8DFD-BA0C808187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A9CAE8-9165-5243-5B3E-0E20A6D922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D40217-E627-609B-09FA-3490BC0637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91334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CFD6F2-9396-3697-BE13-0BF45A3DD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D71173-EAA3-64DC-83F6-CF7A8D8250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14AFCE9-BEBF-0C74-0F85-BF2785D7A8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69F35E9-7AAB-E077-345C-2A95F7B0DEE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69B5307-E4BE-4A9B-CF41-33D61168A7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94B2C5-6B6F-93F2-21AD-78D8B43AC0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D074EC-3FFF-E16A-1294-653F3ECB0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E3098F-AAD5-1696-0D4C-B870CCF31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7331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236137-82B1-D45B-7282-71D57FC306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0F756AE-A043-8400-5D0C-B3CBA4188F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C1C1559-73A9-8EB6-47B5-D2E4BE273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7DEAE34-CE44-28E6-FC0E-1FBF998B8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57712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4CD73E8-C055-692A-A3EF-6EAA342780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A1C7A1F-8B95-07C6-9A19-B485EFC8B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C69834-052F-9838-55C9-8F6ED822DA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23491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019257-EF27-3AD8-11EA-C303D79738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BBF610-CB38-BB00-A55F-161B94E8D5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3379B0C-8874-E9A3-E3DC-2B656EB5D7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0C0D39-FD1F-1BA9-7517-C7DF04A174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6DF7337-3156-4FBC-6E9D-A5DD360CE0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E90F7CB-D278-1130-D5A6-D5F4059F2C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488966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FA737C-BE43-4DF5-76D8-CD24E7317A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12EC040-6282-157B-9573-68A749CCE16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A1560E0-029B-A98A-BE76-CAA60F1545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BF003FC-6146-5672-829A-2A73A3AF2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BEB7A8-8C3B-E265-3B25-64886B60F8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801E96-54F7-77A3-506B-98096F2576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75244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99B13DE-FA5D-1724-078E-2D89AFB2A1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696388-C0A8-E5BD-DAF6-58E07A1474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982029-8F16-E9B2-B1E8-03D52470909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152318-E8C7-48E6-8B62-455CB3B02E35}" type="datetimeFigureOut">
              <a:rPr lang="en-AU" smtClean="0"/>
              <a:t>5/10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687DC1-6D4E-EF98-0454-A0829D8F535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2F32C5-D3E0-6CC2-2159-85DD598A072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186EA-36CD-4F9F-B961-FBB14C4BE2E5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33006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CCC9B1-09A8-66D0-8CBB-A601AD46BC61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AU" dirty="0"/>
              <a:t>Supplementary Figur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867AA1-97A0-6E3D-CB6A-A65BBE6DD0E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AU" dirty="0"/>
          </a:p>
        </p:txBody>
      </p:sp>
    </p:spTree>
    <p:extLst>
      <p:ext uri="{BB962C8B-B14F-4D97-AF65-F5344CB8AC3E}">
        <p14:creationId xmlns:p14="http://schemas.microsoft.com/office/powerpoint/2010/main" val="228766434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2B2B297-EAB6-047F-E65A-5576ED04A227}"/>
              </a:ext>
            </a:extLst>
          </p:cNvPr>
          <p:cNvSpPr txBox="1"/>
          <p:nvPr/>
        </p:nvSpPr>
        <p:spPr>
          <a:xfrm>
            <a:off x="287322" y="5670850"/>
            <a:ext cx="11482431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AU" sz="1800" i="1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ure 1: Principal </a:t>
            </a:r>
            <a:r>
              <a:rPr lang="en-AU" i="1" dirty="0">
                <a:solidFill>
                  <a:srgbClr val="1314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mponent analysis. A) Scree Plot: 80% of the variability in the data was determined by the first 4 principal components. B) </a:t>
            </a:r>
            <a:r>
              <a:rPr lang="en-AU" i="1" dirty="0" err="1">
                <a:solidFill>
                  <a:srgbClr val="1314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igencorplot</a:t>
            </a:r>
            <a:r>
              <a:rPr lang="en-AU" i="1" dirty="0">
                <a:solidFill>
                  <a:srgbClr val="131413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AU" i="1" dirty="0">
                <a:solidFill>
                  <a:srgbClr val="131413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mmarising the correlation between the phenotype variables and the first 4 principal components obtained from the PCA. A negative correlation is expressed in blue, and a positive correlation is expressed in red. *Significant correlation between variable and PC p-value ≤ 0.05</a:t>
            </a:r>
          </a:p>
        </p:txBody>
      </p:sp>
      <p:pic>
        <p:nvPicPr>
          <p:cNvPr id="7" name="Picture 6" descr="A screenshot of a graph&#10;&#10;Description automatically generated">
            <a:extLst>
              <a:ext uri="{FF2B5EF4-FFF2-40B4-BE49-F238E27FC236}">
                <a16:creationId xmlns:a16="http://schemas.microsoft.com/office/drawing/2014/main" id="{7094FDB3-1C3B-3272-B639-A7E41BCBEEF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97000"/>
            <a:ext cx="12192000" cy="40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7190079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9EDA069-83CF-A4FD-194F-203284533923}"/>
              </a:ext>
            </a:extLst>
          </p:cNvPr>
          <p:cNvSpPr txBox="1"/>
          <p:nvPr/>
        </p:nvSpPr>
        <p:spPr>
          <a:xfrm>
            <a:off x="476250" y="5563104"/>
            <a:ext cx="10858500" cy="8788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AU" sz="1800" i="1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ure 2: The proportion of the sex-biased microRNAs genes expressed across the autosomes compared to the sex chromosomes at A) baseline B) after an acute bout of exercise. N=44</a:t>
            </a:r>
            <a:endParaRPr lang="en-AU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 descr="Chart, waterfall chart&#10;&#10;Description automatically generated">
            <a:extLst>
              <a:ext uri="{FF2B5EF4-FFF2-40B4-BE49-F238E27FC236}">
                <a16:creationId xmlns:a16="http://schemas.microsoft.com/office/drawing/2014/main" id="{89643954-B721-34D7-31B2-154D20DF56D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250" y="991104"/>
            <a:ext cx="10972800" cy="457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20844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398F53E5-5724-5D66-E74A-373E696A2A2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7784" y="197375"/>
            <a:ext cx="7813995" cy="520933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7067E7D-6D8E-8D98-D4B6-101038A860AE}"/>
              </a:ext>
            </a:extLst>
          </p:cNvPr>
          <p:cNvSpPr txBox="1"/>
          <p:nvPr/>
        </p:nvSpPr>
        <p:spPr>
          <a:xfrm>
            <a:off x="107309" y="5522378"/>
            <a:ext cx="11977381" cy="8735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AU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 Fig 3: </a:t>
            </a:r>
            <a:r>
              <a:rPr lang="en-AU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ne set enrichment analysis: Top enriched GO terms of baseline male (N=3) and female donor primary cell (N=3). Rich Factor is defined as the ratio of the target genes annotated to a term to the ratio of all genes annotated to that term.</a:t>
            </a:r>
            <a:r>
              <a:rPr lang="en-AU" dirty="0">
                <a:solidFill>
                  <a:srgbClr val="131413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n-AU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12334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60793B49-8D7D-3B4B-727C-8245B4CF48B7}"/>
              </a:ext>
            </a:extLst>
          </p:cNvPr>
          <p:cNvGrpSpPr/>
          <p:nvPr/>
        </p:nvGrpSpPr>
        <p:grpSpPr>
          <a:xfrm>
            <a:off x="383222" y="462050"/>
            <a:ext cx="11808778" cy="4402812"/>
            <a:chOff x="383222" y="462050"/>
            <a:chExt cx="11808778" cy="4402812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8BD5D50-7167-3DD8-3BD5-E3A820964870}"/>
                </a:ext>
              </a:extLst>
            </p:cNvPr>
            <p:cNvSpPr txBox="1"/>
            <p:nvPr/>
          </p:nvSpPr>
          <p:spPr>
            <a:xfrm>
              <a:off x="383222" y="3991290"/>
              <a:ext cx="11036146" cy="87357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just">
                <a:lnSpc>
                  <a:spcPct val="150000"/>
                </a:lnSpc>
                <a:spcAft>
                  <a:spcPts val="800"/>
                </a:spcAft>
              </a:pPr>
              <a:r>
                <a:rPr lang="en-AU" b="1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upp Fig 4: Histogram of unadjusted p values: </a:t>
              </a:r>
              <a:r>
                <a:rPr lang="en-AU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</a:t>
              </a:r>
              <a:r>
                <a:rPr lang="en-AU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ffect of baseline </a:t>
              </a:r>
              <a:r>
                <a:rPr lang="en-AU" b="1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)</a:t>
              </a:r>
              <a:r>
                <a:rPr lang="en-AU" b="1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 </a:t>
              </a:r>
              <a:r>
                <a:rPr lang="en-AU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eak power </a:t>
              </a:r>
              <a:r>
                <a:rPr lang="en-AU" b="1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) </a:t>
              </a:r>
              <a:r>
                <a:rPr lang="en-AU" i="1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a</a:t>
              </a:r>
              <a:r>
                <a:rPr lang="en-AU" i="1" dirty="0"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robic capacity (VO2peak) and changes in miRNA response to acute exercise bout. Model </a:t>
              </a:r>
              <a:r>
                <a:rPr lang="en-AU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iRNA ~ sex + fitness measure* timepoint</a:t>
              </a:r>
              <a:r>
                <a:rPr lang="en-AU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. N=44 </a:t>
              </a:r>
            </a:p>
          </p:txBody>
        </p:sp>
        <p:pic>
          <p:nvPicPr>
            <p:cNvPr id="9" name="Picture 8" descr="A graph of a number of columns&#10;&#10;Description automatically generated">
              <a:extLst>
                <a:ext uri="{FF2B5EF4-FFF2-40B4-BE49-F238E27FC236}">
                  <a16:creationId xmlns:a16="http://schemas.microsoft.com/office/drawing/2014/main" id="{F7BC49C1-EF17-A937-39B8-BB4D8FF91F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1912" y="462050"/>
              <a:ext cx="5820088" cy="3248713"/>
            </a:xfrm>
            <a:prstGeom prst="rect">
              <a:avLst/>
            </a:prstGeom>
          </p:spPr>
        </p:pic>
        <p:pic>
          <p:nvPicPr>
            <p:cNvPr id="11" name="Picture 10" descr="A graph of a graph&#10;&#10;Description automatically generated">
              <a:extLst>
                <a:ext uri="{FF2B5EF4-FFF2-40B4-BE49-F238E27FC236}">
                  <a16:creationId xmlns:a16="http://schemas.microsoft.com/office/drawing/2014/main" id="{03BC018D-C614-7E32-EE40-DF38D4FB669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81321" y="632526"/>
              <a:ext cx="5514679" cy="307823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2498923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6</TotalTime>
  <Words>221</Words>
  <Application>Microsoft Office PowerPoint</Application>
  <PresentationFormat>Widescreen</PresentationFormat>
  <Paragraphs>5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Supplementary Figure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Danielle Hiam</dc:creator>
  <cp:lastModifiedBy>Danielle Hiam</cp:lastModifiedBy>
  <cp:revision>1</cp:revision>
  <dcterms:created xsi:type="dcterms:W3CDTF">2023-04-17T04:14:32Z</dcterms:created>
  <dcterms:modified xsi:type="dcterms:W3CDTF">2023-10-05T22:47:13Z</dcterms:modified>
</cp:coreProperties>
</file>